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74B84-910A-4E76-8E14-6869FC94B2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79792-50CD-411D-A132-4C79314D5E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5CD487-C7B9-49BD-B4CF-8D96DF4690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3E19C-9C76-415B-8406-65158C65CA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BACDA-8AAC-400A-9F0E-4B5A60FB7C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4F3C5C-8BAA-42AE-ABDF-A422BA3CD9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A60FB-496D-4026-9B32-E12BE6D579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63C71-E8E5-4FA9-A0C9-5489F15094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C4BD2-DD01-4181-BDFB-C3BBA36449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11DD4-EFAB-4FE5-9A5C-809AE83C5C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0F543-0A5A-4FEA-A268-D1627C76A2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99E13E-E077-41EC-A751-4535F6DB9D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1ECF29-0B7B-4A04-B4BF-D7FEEF0B227C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952640" y="104760"/>
            <a:ext cx="4714920" cy="598320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3"/>
          <p:cNvSpPr/>
          <p:nvPr/>
        </p:nvSpPr>
        <p:spPr>
          <a:xfrm>
            <a:off x="0" y="6094440"/>
            <a:ext cx="914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. 1:</a:t>
            </a:r>
            <a:r>
              <a:rPr b="0" lang="en-GB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 Relapse-free survival in the TIL + IL-2 group: this difference was not significant (p=0.45; log-rank test); 16.7 years median follow-up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5" descr=""/>
          <p:cNvPicPr/>
          <p:nvPr/>
        </p:nvPicPr>
        <p:blipFill>
          <a:blip r:embed="rId1"/>
          <a:stretch/>
        </p:blipFill>
        <p:spPr>
          <a:xfrm>
            <a:off x="1952640" y="104760"/>
            <a:ext cx="4714920" cy="598320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3"/>
          <p:cNvSpPr/>
          <p:nvPr/>
        </p:nvSpPr>
        <p:spPr>
          <a:xfrm>
            <a:off x="755640" y="6237360"/>
            <a:ext cx="7848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. 2.</a:t>
            </a:r>
            <a:r>
              <a:rPr b="0" lang="en-GB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: Cox model curves for the conditions Breslow &gt;1.5, capsular breaking and only one invaded lymph nod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"/>
          <p:cNvPicPr/>
          <p:nvPr/>
        </p:nvPicPr>
        <p:blipFill>
          <a:blip r:embed="rId1"/>
          <a:stretch/>
        </p:blipFill>
        <p:spPr>
          <a:xfrm>
            <a:off x="1952640" y="104760"/>
            <a:ext cx="4714920" cy="5983200"/>
          </a:xfrm>
          <a:prstGeom prst="rect">
            <a:avLst/>
          </a:prstGeom>
          <a:ln w="0">
            <a:noFill/>
          </a:ln>
        </p:spPr>
      </p:pic>
      <p:sp>
        <p:nvSpPr>
          <p:cNvPr id="46" name="Rectangle 2"/>
          <p:cNvSpPr/>
          <p:nvPr/>
        </p:nvSpPr>
        <p:spPr>
          <a:xfrm>
            <a:off x="0" y="6007680"/>
            <a:ext cx="914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. 3.</a:t>
            </a:r>
            <a:r>
              <a:rPr b="0" lang="en-GB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 The overall survival rate between the TIL + IL-2 group and IL-2 group was not significantly different (p=0.39; log-rank test); 16.7 years median follow-up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3" descr=""/>
          <p:cNvPicPr/>
          <p:nvPr/>
        </p:nvPicPr>
        <p:blipFill>
          <a:blip r:embed="rId1"/>
          <a:stretch/>
        </p:blipFill>
        <p:spPr>
          <a:xfrm>
            <a:off x="2195640" y="115920"/>
            <a:ext cx="4714920" cy="5983200"/>
          </a:xfrm>
          <a:prstGeom prst="rect">
            <a:avLst/>
          </a:prstGeom>
          <a:ln w="0">
            <a:noFill/>
          </a:ln>
        </p:spPr>
      </p:pic>
      <p:sp>
        <p:nvSpPr>
          <p:cNvPr id="48" name="Rectangle 2"/>
          <p:cNvSpPr/>
          <p:nvPr/>
        </p:nvSpPr>
        <p:spPr>
          <a:xfrm>
            <a:off x="0" y="6099120"/>
            <a:ext cx="914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. 4. </a:t>
            </a:r>
            <a:r>
              <a:rPr b="0" lang="en-GB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x survival curves in the conditions of only one nodes invaded, Breslow thickness ≥1.5 and capsular breaking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16T16:27:27Z</dcterms:created>
  <dc:creator>jmnguyen</dc:creator>
  <dc:description/>
  <dc:language>en-US</dc:language>
  <cp:lastModifiedBy>Anne_2</cp:lastModifiedBy>
  <dcterms:modified xsi:type="dcterms:W3CDTF">2013-07-18T08:43:33Z</dcterms:modified>
  <cp:revision>9</cp:revision>
  <dc:subject/>
  <dc:title>Présentation PowerPoint</dc:title>
</cp:coreProperties>
</file>